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ct" ContentType="image/x-pict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70898-D507-4C2D-9AEA-15BF6DD20F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A8E134-6930-4CFE-AA4B-D19E88628C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2918B-F685-4BB3-97C4-0A3CB201E9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67019-F629-4565-BDCF-F93AB07746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55D05-BE46-40C6-AAFB-1319B9C52F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4954C-C824-46F5-9791-7D0C7BECBA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50920-FFD7-4588-A8DE-517A791E79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12A08-2DB6-4E44-9C12-7F0033D096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1DD22-663B-4EFC-AF84-70B33861DB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60565-B8B7-4F8D-8BCE-DD1EBBC0A7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E5B3B3-8730-4D1A-A13C-BCDEA9E088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0098C-1FA5-42B3-B8DC-4426724554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A39A6D-12A8-463C-A9D5-8E4C7DF7D35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9.pct"/><Relationship Id="rId4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2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1314360" cy="25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gure 1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254320" y="2862360"/>
            <a:ext cx="2349360" cy="341928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2310840" y="5796000"/>
            <a:ext cx="683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100nm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4" name="PlaceHolder 1"/>
          <p:cNvSpPr>
            <a:spLocks noGrp="1"/>
          </p:cNvSpPr>
          <p:nvPr>
            <p:ph type="title"/>
          </p:nvPr>
        </p:nvSpPr>
        <p:spPr>
          <a:xfrm>
            <a:off x="304560" y="380520"/>
            <a:ext cx="2438280" cy="406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. Fig. 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5" name="" descr=""/>
          <p:cNvPicPr/>
          <p:nvPr/>
        </p:nvPicPr>
        <p:blipFill>
          <a:blip r:embed="rId1"/>
          <a:stretch/>
        </p:blipFill>
        <p:spPr>
          <a:xfrm>
            <a:off x="189000" y="3676680"/>
            <a:ext cx="6478560" cy="179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6" name="" descr=""/>
          <p:cNvPicPr/>
          <p:nvPr/>
        </p:nvPicPr>
        <p:blipFill>
          <a:blip r:embed="rId1"/>
          <a:srcRect l="0" t="22759" r="0" b="18207"/>
          <a:stretch/>
        </p:blipFill>
        <p:spPr>
          <a:xfrm>
            <a:off x="76320" y="2163600"/>
            <a:ext cx="6646680" cy="5218200"/>
          </a:xfrm>
          <a:prstGeom prst="rect">
            <a:avLst/>
          </a:prstGeom>
          <a:ln w="0">
            <a:noFill/>
          </a:ln>
        </p:spPr>
      </p:pic>
      <p:sp>
        <p:nvSpPr>
          <p:cNvPr id="637" name="PlaceHolder 1"/>
          <p:cNvSpPr>
            <a:spLocks noGrp="1"/>
          </p:cNvSpPr>
          <p:nvPr>
            <p:ph type="title"/>
          </p:nvPr>
        </p:nvSpPr>
        <p:spPr>
          <a:xfrm>
            <a:off x="304560" y="380520"/>
            <a:ext cx="2438280" cy="406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. Fig. 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>
            <a:off x="5808960" y="6489720"/>
            <a:ext cx="908640" cy="231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" rIns="9000" tIns="9000" bIns="9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0303"/>
                </a:solidFill>
                <a:latin typeface="Arial"/>
              </a:rPr>
              <a:t>Siphovirus P-SS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0303"/>
                </a:solidFill>
                <a:latin typeface="Arial"/>
              </a:rPr>
              <a:t>Marine JCVI sequenc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39" name=""/>
          <p:cNvGraphicFramePr/>
          <p:nvPr/>
        </p:nvGraphicFramePr>
        <p:xfrm>
          <a:off x="4419720" y="1905120"/>
          <a:ext cx="1879560" cy="376560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640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4419720" y="1905120"/>
                    <a:ext cx="1879560" cy="376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41" name=""/>
          <p:cNvSpPr/>
          <p:nvPr/>
        </p:nvSpPr>
        <p:spPr>
          <a:xfrm>
            <a:off x="5965920" y="6248520"/>
            <a:ext cx="594720" cy="20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" rIns="9000" tIns="9000" bIns="9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IT930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41ef6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41ef6"/>
                </a:solidFill>
                <a:latin typeface="Arial"/>
              </a:rPr>
              <a:t>Host MIT931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2" name=""/>
          <p:cNvSpPr/>
          <p:nvPr/>
        </p:nvSpPr>
        <p:spPr>
          <a:xfrm>
            <a:off x="3292560" y="3192480"/>
            <a:ext cx="271440" cy="3049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PlaceHolder 1"/>
          <p:cNvSpPr>
            <a:spLocks noGrp="1"/>
          </p:cNvSpPr>
          <p:nvPr>
            <p:ph type="title"/>
          </p:nvPr>
        </p:nvSpPr>
        <p:spPr>
          <a:xfrm>
            <a:off x="514440" y="812880"/>
            <a:ext cx="1923840" cy="55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. Fig. 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4" name="" descr=""/>
          <p:cNvPicPr/>
          <p:nvPr/>
        </p:nvPicPr>
        <p:blipFill>
          <a:blip r:embed="rId1"/>
          <a:stretch/>
        </p:blipFill>
        <p:spPr>
          <a:xfrm>
            <a:off x="3716280" y="2546280"/>
            <a:ext cx="2913120" cy="1701720"/>
          </a:xfrm>
          <a:prstGeom prst="rect">
            <a:avLst/>
          </a:prstGeom>
          <a:ln w="0">
            <a:noFill/>
          </a:ln>
        </p:spPr>
      </p:pic>
      <p:pic>
        <p:nvPicPr>
          <p:cNvPr id="645" name="" descr=""/>
          <p:cNvPicPr/>
          <p:nvPr/>
        </p:nvPicPr>
        <p:blipFill>
          <a:blip r:embed="rId2"/>
          <a:stretch/>
        </p:blipFill>
        <p:spPr>
          <a:xfrm>
            <a:off x="793800" y="2529000"/>
            <a:ext cx="2922480" cy="1866960"/>
          </a:xfrm>
          <a:prstGeom prst="rect">
            <a:avLst/>
          </a:prstGeom>
          <a:ln w="0">
            <a:noFill/>
          </a:ln>
        </p:spPr>
      </p:pic>
      <p:sp>
        <p:nvSpPr>
          <p:cNvPr id="646" name=""/>
          <p:cNvSpPr/>
          <p:nvPr/>
        </p:nvSpPr>
        <p:spPr>
          <a:xfrm rot="16200000">
            <a:off x="-120240" y="3063240"/>
            <a:ext cx="696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%G+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592200" y="4267080"/>
            <a:ext cx="66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6188040" y="4267080"/>
            <a:ext cx="685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8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>
            <a:off x="784080" y="2514600"/>
            <a:ext cx="9720" cy="1701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395280" y="404640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8360" rIns="1836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>
            <a:off x="379440" y="240660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8360" rIns="1836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>
            <a:off x="393840" y="320832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8360" rIns="1836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52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2017440" y="4343400"/>
            <a:ext cx="2939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iphovirus P-SS2 genome posi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 rot="5400000">
            <a:off x="-964440" y="1573560"/>
            <a:ext cx="8382240" cy="6453360"/>
          </a:xfrm>
          <a:prstGeom prst="rect">
            <a:avLst/>
          </a:prstGeom>
          <a:ln w="0">
            <a:noFill/>
          </a:ln>
        </p:spPr>
      </p:pic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75960" y="75960"/>
            <a:ext cx="1447560" cy="43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gure 1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5400000">
            <a:off x="-976680" y="4105800"/>
            <a:ext cx="36554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age attachment si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mbdoid phage featu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yanobacterial featu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perimentally determined structural prote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09480" y="2514600"/>
            <a:ext cx="228600" cy="228600"/>
          </a:xfrm>
          <a:prstGeom prst="rect">
            <a:avLst/>
          </a:prstGeom>
          <a:solidFill>
            <a:srgbClr val="00883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80880" y="2514600"/>
            <a:ext cx="228600" cy="22860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044720" y="2514600"/>
            <a:ext cx="228600" cy="228600"/>
          </a:xfrm>
          <a:prstGeom prst="rect">
            <a:avLst/>
          </a:prstGeom>
          <a:solidFill>
            <a:srgbClr val="041ef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38080" y="2514600"/>
            <a:ext cx="228600" cy="228600"/>
          </a:xfrm>
          <a:prstGeom prst="rect">
            <a:avLst/>
          </a:prstGeom>
          <a:solidFill>
            <a:srgbClr val="f60f0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905120" y="4954680"/>
            <a:ext cx="152280" cy="46080"/>
          </a:xfrm>
          <a:prstGeom prst="rect">
            <a:avLst/>
          </a:prstGeom>
          <a:solidFill>
            <a:srgbClr val="041ef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5400000">
            <a:off x="4256640" y="7122240"/>
            <a:ext cx="477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4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5400000">
            <a:off x="1633680" y="7162920"/>
            <a:ext cx="76176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7.5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5400000">
            <a:off x="1796040" y="213120"/>
            <a:ext cx="477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4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5400000">
            <a:off x="4276800" y="289440"/>
            <a:ext cx="4780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5400000">
            <a:off x="3078720" y="2733840"/>
            <a:ext cx="1584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60f0c"/>
                </a:solidFill>
                <a:latin typeface="Arial"/>
              </a:rPr>
              <a:t>capsid form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60f0c"/>
                </a:solidFill>
                <a:latin typeface="Arial"/>
              </a:rPr>
              <a:t>(5 proteins detecte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5400000">
            <a:off x="2728440" y="5645160"/>
            <a:ext cx="258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60f0c"/>
                </a:solidFill>
                <a:latin typeface="Arial"/>
              </a:rPr>
              <a:t>tail formation (28 proteins detecte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5400000">
            <a:off x="212400" y="2303280"/>
            <a:ext cx="258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60f0c"/>
                </a:solidFill>
                <a:latin typeface="Arial"/>
              </a:rPr>
              <a:t>tail formation (28 proteins detecte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5400000">
            <a:off x="3088800" y="1213200"/>
            <a:ext cx="105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60f0c"/>
                </a:solidFill>
                <a:latin typeface="Arial"/>
              </a:rPr>
              <a:t>ORFs 9 + 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733920" y="1359000"/>
            <a:ext cx="3045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720960" y="1359000"/>
            <a:ext cx="393840" cy="8506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44280" y="380880"/>
            <a:ext cx="6772320" cy="8763120"/>
          </a:xfrm>
          <a:prstGeom prst="rect">
            <a:avLst/>
          </a:prstGeom>
          <a:ln w="0">
            <a:noFill/>
          </a:ln>
        </p:spPr>
      </p:pic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228240" y="304560"/>
            <a:ext cx="1771560" cy="406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gure 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-360" y="0"/>
            <a:ext cx="152388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gure 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88920" y="838080"/>
            <a:ext cx="228600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ost genome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 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Prochlorococcu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MIT931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006720" y="852480"/>
            <a:ext cx="82440" cy="856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045960" y="777960"/>
            <a:ext cx="27410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seudogene of tRNA-Met2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if11 domain, N-stress prote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posase or degraded derivativ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6bp exact match of tRNA-Met2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009960" y="1028880"/>
            <a:ext cx="82440" cy="85680"/>
          </a:xfrm>
          <a:prstGeom prst="rect">
            <a:avLst/>
          </a:prstGeom>
          <a:solidFill>
            <a:srgbClr val="f61302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002040" y="1198440"/>
            <a:ext cx="82440" cy="8568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3284640" y="3123720"/>
            <a:ext cx="1828800" cy="236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V="1">
            <a:off x="2095560" y="2209680"/>
            <a:ext cx="419040" cy="495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H="1" flipV="1">
            <a:off x="2742840" y="2209320"/>
            <a:ext cx="2476440" cy="507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H="1" flipV="1">
            <a:off x="2064960" y="3123720"/>
            <a:ext cx="1143000" cy="236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924200" y="2690640"/>
            <a:ext cx="3504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AGATTTGAACTCCCGACCTTCGGGTTATGAGCCCGAATAGACAGGGGCAGAT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|||||||||||||||||||||||||||||||||||||||||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TCTAAACTTGAGGGCTGGAAGCCCAATACTCGGGCTTATCTGTCCCCGTCTAG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222520" y="2714760"/>
            <a:ext cx="1499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3bp exact match =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ssible integration si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690560" y="3614760"/>
            <a:ext cx="2925720" cy="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622600" y="3384720"/>
            <a:ext cx="533520" cy="20088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i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308400" y="3386160"/>
            <a:ext cx="380880" cy="20088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e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801960" y="3376440"/>
            <a:ext cx="2588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860480" y="3386160"/>
            <a:ext cx="533520" cy="20088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ysoz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443320" y="3378240"/>
            <a:ext cx="27000" cy="255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517840" y="3378240"/>
            <a:ext cx="27000" cy="255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070520" y="3365640"/>
            <a:ext cx="26640" cy="255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110120" y="3365640"/>
            <a:ext cx="27000" cy="255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249800" y="3376440"/>
            <a:ext cx="2588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603680" y="3462480"/>
            <a:ext cx="45720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5028480" y="3340080"/>
            <a:ext cx="1701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NA replication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5560" y="3357720"/>
            <a:ext cx="12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tructural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H="1">
            <a:off x="1251000" y="3462480"/>
            <a:ext cx="45720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5400000">
            <a:off x="5468400" y="1445040"/>
            <a:ext cx="106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RNA-Met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243880" y="3886200"/>
            <a:ext cx="195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3bp putative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ttP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si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481120" y="1884240"/>
            <a:ext cx="2117880" cy="56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69800" y="2133720"/>
            <a:ext cx="6083280" cy="2376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832120" y="1959120"/>
            <a:ext cx="382680" cy="1872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463840" y="1959120"/>
            <a:ext cx="55440" cy="17928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303640" y="2162160"/>
            <a:ext cx="83880" cy="217440"/>
          </a:xfrm>
          <a:prstGeom prst="rect">
            <a:avLst/>
          </a:prstGeom>
          <a:solidFill>
            <a:srgbClr val="f61302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235240" y="2162160"/>
            <a:ext cx="55440" cy="21744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787400" y="2162160"/>
            <a:ext cx="84240" cy="217440"/>
          </a:xfrm>
          <a:prstGeom prst="rect">
            <a:avLst/>
          </a:prstGeom>
          <a:solidFill>
            <a:srgbClr val="f61302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717560" y="2162160"/>
            <a:ext cx="55800" cy="21744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581800" y="2162160"/>
            <a:ext cx="83880" cy="217440"/>
          </a:xfrm>
          <a:prstGeom prst="rect">
            <a:avLst/>
          </a:prstGeom>
          <a:solidFill>
            <a:srgbClr val="f61302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514840" y="2162160"/>
            <a:ext cx="55800" cy="21744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132520" y="2162160"/>
            <a:ext cx="85680" cy="217440"/>
          </a:xfrm>
          <a:prstGeom prst="rect">
            <a:avLst/>
          </a:prstGeom>
          <a:solidFill>
            <a:srgbClr val="f61302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5067360" y="2162160"/>
            <a:ext cx="54000" cy="21744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354480" y="1959120"/>
            <a:ext cx="85680" cy="179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471840" y="1959120"/>
            <a:ext cx="304920" cy="18720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867120" y="1959120"/>
            <a:ext cx="39600" cy="1792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951360" y="2162160"/>
            <a:ext cx="84240" cy="217440"/>
          </a:xfrm>
          <a:prstGeom prst="rect">
            <a:avLst/>
          </a:prstGeom>
          <a:solidFill>
            <a:srgbClr val="f61302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4140360" y="1959120"/>
            <a:ext cx="85680" cy="17928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4484520" y="1959120"/>
            <a:ext cx="179640" cy="179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886040" y="1959120"/>
            <a:ext cx="231840" cy="17928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4683240" y="1959120"/>
            <a:ext cx="306360" cy="18720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5276880" y="1959120"/>
            <a:ext cx="179280" cy="17928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5700600" y="1959120"/>
            <a:ext cx="179640" cy="17928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5991120" y="2163600"/>
            <a:ext cx="55800" cy="21600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474920" y="1959120"/>
            <a:ext cx="231480" cy="17928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255680" y="2154240"/>
            <a:ext cx="179280" cy="1810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914400" y="1959120"/>
            <a:ext cx="179280" cy="179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801720" y="2162160"/>
            <a:ext cx="68400" cy="179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6108840" y="2174760"/>
            <a:ext cx="380880" cy="2066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6023880" y="214488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ns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06720" y="19051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c700b"/>
                </a:solidFill>
                <a:latin typeface="Arial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609480" y="1955880"/>
            <a:ext cx="179640" cy="179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104840" y="2158920"/>
            <a:ext cx="141480" cy="1810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459160" y="19303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c700b"/>
                </a:solidFill>
                <a:latin typeface="Arial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081600" y="19432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c700b"/>
                </a:solidFill>
                <a:latin typeface="Arial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167360" y="19432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c700b"/>
                </a:solidFill>
                <a:latin typeface="Arial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5824800" y="19432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c700b"/>
                </a:solidFill>
                <a:latin typeface="Arial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003400" y="1579680"/>
            <a:ext cx="1274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3bp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ttB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si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896920" y="12636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c700b"/>
                </a:solidFill>
                <a:latin typeface="Arial"/>
              </a:rPr>
              <a:t>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6122880" y="1905120"/>
            <a:ext cx="73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03,45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0" y="2209680"/>
            <a:ext cx="73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16,34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038760" y="33955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c700b"/>
                </a:solidFill>
                <a:latin typeface="Arial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97560" y="2666880"/>
            <a:ext cx="157968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hage genome 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iphovirus P-S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295280" y="365760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7,3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343400" y="365760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4,4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H="1" flipV="1">
            <a:off x="3224160" y="3674880"/>
            <a:ext cx="7920" cy="261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649600" y="1846440"/>
            <a:ext cx="0" cy="191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" descr=""/>
          <p:cNvPicPr/>
          <p:nvPr/>
        </p:nvPicPr>
        <p:blipFill>
          <a:blip r:embed="rId1"/>
          <a:srcRect l="0" t="4794" r="0" b="0"/>
          <a:stretch/>
        </p:blipFill>
        <p:spPr>
          <a:xfrm>
            <a:off x="743040" y="1744560"/>
            <a:ext cx="5283000" cy="4721400"/>
          </a:xfrm>
          <a:prstGeom prst="rect">
            <a:avLst/>
          </a:prstGeom>
          <a:ln w="0">
            <a:noFill/>
          </a:ln>
        </p:spPr>
      </p:pic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75960" y="50400"/>
            <a:ext cx="1447560" cy="406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gure 4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flipV="1">
            <a:off x="4933800" y="1492200"/>
            <a:ext cx="779760" cy="79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5103360" y="147780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flipH="1">
            <a:off x="1809360" y="3909960"/>
            <a:ext cx="779400" cy="6480"/>
          </a:xfrm>
          <a:prstGeom prst="line">
            <a:avLst/>
          </a:prstGeom>
          <a:ln w="28440">
            <a:solidFill>
              <a:srgbClr val="fe09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025720" y="974880"/>
            <a:ext cx="3441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enome conservation breakpoint @ tRNA-Met + An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 Putative integration site for P-SS2 in ProMIT93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819000" y="1744560"/>
            <a:ext cx="9018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rot="16200000">
            <a:off x="525240" y="906120"/>
            <a:ext cx="1209600" cy="46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Highly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onserv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cross genom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758880" y="166860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743040" y="171936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743040" y="219384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735120" y="291636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735120" y="3395520"/>
            <a:ext cx="3039840" cy="101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743040" y="3624120"/>
            <a:ext cx="3039840" cy="101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766800" y="3865680"/>
            <a:ext cx="304020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743040" y="434664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743040" y="458316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690480" y="4821120"/>
            <a:ext cx="3040200" cy="101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758880" y="528804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758880" y="552924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743040" y="576756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735120" y="5999040"/>
            <a:ext cx="3039840" cy="101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743040" y="652788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76320" y="1668600"/>
            <a:ext cx="896760" cy="487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92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93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93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96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D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95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ATL2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1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92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930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93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H81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96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H780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H78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99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743040" y="196524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743040" y="243684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743040" y="2700360"/>
            <a:ext cx="3039840" cy="85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758880" y="3159000"/>
            <a:ext cx="3039840" cy="101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743040" y="410544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743040" y="5052960"/>
            <a:ext cx="303984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774720" y="6251400"/>
            <a:ext cx="3040200" cy="101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1733400" y="2712960"/>
            <a:ext cx="1447920" cy="457200"/>
          </a:xfrm>
          <a:prstGeom prst="rect">
            <a:avLst/>
          </a:prstGeom>
          <a:noFill/>
          <a:ln w="28440">
            <a:solidFill>
              <a:srgbClr val="fe09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449520" y="4081320"/>
            <a:ext cx="3240" cy="257400"/>
          </a:xfrm>
          <a:prstGeom prst="line">
            <a:avLst/>
          </a:prstGeom>
          <a:ln w="28440">
            <a:solidFill>
              <a:srgbClr val="fe09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809720" y="6292800"/>
            <a:ext cx="3046320" cy="219240"/>
          </a:xfrm>
          <a:prstGeom prst="rect">
            <a:avLst/>
          </a:prstGeom>
          <a:noFill/>
          <a:ln w="28440">
            <a:solidFill>
              <a:srgbClr val="fe09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1789200" y="4334040"/>
            <a:ext cx="1666800" cy="1440"/>
          </a:xfrm>
          <a:prstGeom prst="line">
            <a:avLst/>
          </a:prstGeom>
          <a:ln w="28440">
            <a:solidFill>
              <a:srgbClr val="fe09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1800360" y="3913200"/>
            <a:ext cx="0" cy="422280"/>
          </a:xfrm>
          <a:prstGeom prst="line">
            <a:avLst/>
          </a:prstGeom>
          <a:ln w="28440">
            <a:solidFill>
              <a:srgbClr val="fe09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2786040" y="3913200"/>
            <a:ext cx="0" cy="193680"/>
          </a:xfrm>
          <a:prstGeom prst="line">
            <a:avLst/>
          </a:prstGeom>
          <a:ln w="28440">
            <a:solidFill>
              <a:srgbClr val="fe09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779560" y="4094280"/>
            <a:ext cx="663840" cy="0"/>
          </a:xfrm>
          <a:prstGeom prst="line">
            <a:avLst/>
          </a:prstGeom>
          <a:ln w="28440">
            <a:solidFill>
              <a:srgbClr val="fe09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1790640" y="3911760"/>
            <a:ext cx="1001880" cy="0"/>
          </a:xfrm>
          <a:prstGeom prst="line">
            <a:avLst/>
          </a:prstGeom>
          <a:ln w="28440">
            <a:solidFill>
              <a:srgbClr val="fe09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H="1">
            <a:off x="1886040" y="1371600"/>
            <a:ext cx="45720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flipV="1">
            <a:off x="806400" y="1731960"/>
            <a:ext cx="779400" cy="7920"/>
          </a:xfrm>
          <a:prstGeom prst="line">
            <a:avLst/>
          </a:prstGeom>
          <a:ln w="38160">
            <a:solidFill>
              <a:srgbClr val="041ef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100240" y="6705720"/>
            <a:ext cx="262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enomic island region, detailed in Fig. 4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V="1" rot="5400000">
            <a:off x="3319200" y="5090760"/>
            <a:ext cx="200160" cy="3124440"/>
          </a:xfrm>
          <a:custGeom>
            <a:avLst/>
            <a:gdLst>
              <a:gd name="textAreaLeft" fmla="*/ 0 w 200160"/>
              <a:gd name="textAreaRight" fmla="*/ 72360 w 200160"/>
              <a:gd name="textAreaTop" fmla="*/ 81360 h 3124440"/>
              <a:gd name="textAreaBottom" fmla="*/ 3043080 h 3124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rot="5400000">
            <a:off x="1284120" y="1373760"/>
            <a:ext cx="796320" cy="36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RNA-Me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ns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5924520" y="1797120"/>
            <a:ext cx="187200" cy="838080"/>
          </a:xfrm>
          <a:custGeom>
            <a:avLst/>
            <a:gdLst>
              <a:gd name="textAreaLeft" fmla="*/ 0 w 187200"/>
              <a:gd name="textAreaRight" fmla="*/ 67680 w 187200"/>
              <a:gd name="textAreaTop" fmla="*/ 21600 h 838080"/>
              <a:gd name="textAreaBottom" fmla="*/ 816480 h 838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6003360" y="2008080"/>
            <a:ext cx="616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 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e931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5938920" y="2743200"/>
            <a:ext cx="137880" cy="1143000"/>
          </a:xfrm>
          <a:custGeom>
            <a:avLst/>
            <a:gdLst>
              <a:gd name="textAreaLeft" fmla="*/ 0 w 137880"/>
              <a:gd name="textAreaRight" fmla="*/ 49680 w 137880"/>
              <a:gd name="textAreaTop" fmla="*/ 29520 h 1143000"/>
              <a:gd name="textAreaBottom" fmla="*/ 1113480 h 1143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5988600" y="2955960"/>
            <a:ext cx="81936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 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MED4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Ls, no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T9515**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3181320" y="2975040"/>
            <a:ext cx="2768760" cy="9360"/>
          </a:xfrm>
          <a:prstGeom prst="line">
            <a:avLst/>
          </a:prstGeom>
          <a:ln w="38160">
            <a:solidFill>
              <a:srgbClr val="e30508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6027480" y="3927600"/>
            <a:ext cx="616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I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e9313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5938920" y="3930480"/>
            <a:ext cx="137880" cy="381240"/>
          </a:xfrm>
          <a:custGeom>
            <a:avLst/>
            <a:gdLst>
              <a:gd name="textAreaLeft" fmla="*/ 0 w 137880"/>
              <a:gd name="textAreaRight" fmla="*/ 49680 w 137880"/>
              <a:gd name="textAreaTop" fmla="*/ 9720 h 381240"/>
              <a:gd name="textAreaBottom" fmla="*/ 371520 h 381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5924520" y="4343400"/>
            <a:ext cx="176400" cy="1905120"/>
          </a:xfrm>
          <a:custGeom>
            <a:avLst/>
            <a:gdLst>
              <a:gd name="textAreaLeft" fmla="*/ 0 w 176400"/>
              <a:gd name="textAreaRight" fmla="*/ 63720 w 176400"/>
              <a:gd name="textAreaTop" fmla="*/ 49680 h 1905120"/>
              <a:gd name="textAreaBottom" fmla="*/ 1855440 h 19051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6044400" y="5105520"/>
            <a:ext cx="715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ynecho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occu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5033520" y="6264360"/>
            <a:ext cx="9943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nRS99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PlaceHolder 1"/>
          <p:cNvSpPr>
            <a:spLocks noGrp="1"/>
          </p:cNvSpPr>
          <p:nvPr>
            <p:ph type="title"/>
          </p:nvPr>
        </p:nvSpPr>
        <p:spPr>
          <a:xfrm>
            <a:off x="151920" y="228240"/>
            <a:ext cx="1924200" cy="406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695160" y="3440160"/>
            <a:ext cx="184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19240" y="717480"/>
            <a:ext cx="212688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Synechococcu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RS99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RNA-Met +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ns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 rot="21300000">
            <a:off x="1517760" y="2374560"/>
            <a:ext cx="3254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~27kb of highly syntenic genome awa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rot="16200000">
            <a:off x="3011040" y="1712880"/>
            <a:ext cx="1143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05bp ga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7" name=""/>
          <p:cNvGrpSpPr/>
          <p:nvPr/>
        </p:nvGrpSpPr>
        <p:grpSpPr>
          <a:xfrm>
            <a:off x="222120" y="2057400"/>
            <a:ext cx="3283200" cy="254160"/>
            <a:chOff x="222120" y="2057400"/>
            <a:chExt cx="3283200" cy="254160"/>
          </a:xfrm>
        </p:grpSpPr>
        <p:sp>
          <p:nvSpPr>
            <p:cNvPr id="198" name=""/>
            <p:cNvSpPr/>
            <p:nvPr/>
          </p:nvSpPr>
          <p:spPr>
            <a:xfrm flipV="1">
              <a:off x="222120" y="2175120"/>
              <a:ext cx="3283200" cy="10440"/>
            </a:xfrm>
            <a:prstGeom prst="line">
              <a:avLst/>
            </a:prstGeom>
            <a:ln w="381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360" bIns="-36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1708200" y="2057400"/>
              <a:ext cx="158760" cy="118080"/>
            </a:xfrm>
            <a:prstGeom prst="rect">
              <a:avLst/>
            </a:prstGeom>
            <a:solidFill>
              <a:srgbClr val="041ef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1552320" y="2193120"/>
              <a:ext cx="3060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1591200" y="2193120"/>
              <a:ext cx="4608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1446480" y="2057400"/>
              <a:ext cx="3024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1211760" y="2193120"/>
              <a:ext cx="2844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1173600" y="2193120"/>
              <a:ext cx="2844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3191760" y="2193120"/>
              <a:ext cx="122400" cy="118440"/>
            </a:xfrm>
            <a:prstGeom prst="rect">
              <a:avLst/>
            </a:prstGeom>
            <a:solidFill>
              <a:srgbClr val="ffff08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2806200" y="2193120"/>
              <a:ext cx="3852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2770920" y="2193120"/>
              <a:ext cx="3852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2136960" y="2193120"/>
              <a:ext cx="16632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1872720" y="2057400"/>
              <a:ext cx="21240" cy="118080"/>
            </a:xfrm>
            <a:prstGeom prst="rect">
              <a:avLst/>
            </a:prstGeom>
            <a:solidFill>
              <a:srgbClr val="041ef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2307600" y="2057400"/>
              <a:ext cx="4608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2486160" y="2057400"/>
              <a:ext cx="8064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3078720" y="2057400"/>
              <a:ext cx="97920" cy="118080"/>
            </a:xfrm>
            <a:prstGeom prst="rect">
              <a:avLst/>
            </a:prstGeom>
            <a:solidFill>
              <a:srgbClr val="ffff08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3344040" y="2057400"/>
              <a:ext cx="80640" cy="118080"/>
            </a:xfrm>
            <a:prstGeom prst="rect">
              <a:avLst/>
            </a:prstGeom>
            <a:solidFill>
              <a:srgbClr val="2002fc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817920" y="2057400"/>
              <a:ext cx="85680" cy="1180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620640" y="2193120"/>
              <a:ext cx="180000" cy="1184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01840" y="2057400"/>
              <a:ext cx="119880" cy="1180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416160" y="2193120"/>
              <a:ext cx="37800" cy="1184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3034440" y="2057400"/>
              <a:ext cx="2844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2991600" y="2057400"/>
              <a:ext cx="2844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2943720" y="2057400"/>
              <a:ext cx="2844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2674080" y="2193120"/>
              <a:ext cx="8460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2631960" y="2193120"/>
              <a:ext cx="3852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2570760" y="2057400"/>
              <a:ext cx="2124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2367720" y="2057400"/>
              <a:ext cx="4608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1905480" y="2057400"/>
              <a:ext cx="2124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1974960" y="2193120"/>
              <a:ext cx="11340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2101680" y="2193120"/>
              <a:ext cx="972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1285920" y="2193120"/>
              <a:ext cx="3924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1328400" y="2193120"/>
              <a:ext cx="4608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1261080" y="2193120"/>
              <a:ext cx="972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1117800" y="2057400"/>
              <a:ext cx="2844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1080000" y="2057400"/>
              <a:ext cx="28800" cy="1180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75120" y="2193120"/>
              <a:ext cx="37440" cy="1184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62240" y="2057400"/>
              <a:ext cx="37800" cy="1180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936720" y="2193120"/>
              <a:ext cx="54720" cy="1184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1000800" y="2193120"/>
              <a:ext cx="9720" cy="118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7" name=""/>
          <p:cNvSpPr/>
          <p:nvPr/>
        </p:nvSpPr>
        <p:spPr>
          <a:xfrm flipV="1">
            <a:off x="3657600" y="2180880"/>
            <a:ext cx="2890800" cy="324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4654440" y="2057400"/>
            <a:ext cx="19548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4616280" y="2198520"/>
            <a:ext cx="30240" cy="12384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4290840" y="2057400"/>
            <a:ext cx="4140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986280" y="2198520"/>
            <a:ext cx="4608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5886360" y="2198520"/>
            <a:ext cx="227160" cy="123840"/>
          </a:xfrm>
          <a:prstGeom prst="rect">
            <a:avLst/>
          </a:prstGeom>
          <a:solidFill>
            <a:srgbClr val="041ef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5815080" y="2057400"/>
            <a:ext cx="3636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5861160" y="2057400"/>
            <a:ext cx="936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4846680" y="2057400"/>
            <a:ext cx="10620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5168880" y="2057400"/>
            <a:ext cx="2052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5291280" y="2198520"/>
            <a:ext cx="7452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5372280" y="2198520"/>
            <a:ext cx="2664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4191120" y="2057400"/>
            <a:ext cx="7452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6114960" y="2198520"/>
            <a:ext cx="95400" cy="123840"/>
          </a:xfrm>
          <a:prstGeom prst="rect">
            <a:avLst/>
          </a:prstGeom>
          <a:solidFill>
            <a:srgbClr val="041ef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6267600" y="2198520"/>
            <a:ext cx="29880" cy="12384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4046400" y="2057400"/>
            <a:ext cx="13824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3701880" y="2057400"/>
            <a:ext cx="125640" cy="123840"/>
          </a:xfrm>
          <a:prstGeom prst="rect">
            <a:avLst/>
          </a:prstGeom>
          <a:solidFill>
            <a:srgbClr val="041ef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5730840" y="2198520"/>
            <a:ext cx="4464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5697360" y="2198520"/>
            <a:ext cx="2880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5618160" y="2057400"/>
            <a:ext cx="4428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5232240" y="2198520"/>
            <a:ext cx="4140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5105520" y="2057400"/>
            <a:ext cx="6192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5057640" y="2057400"/>
            <a:ext cx="3816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5027760" y="2057400"/>
            <a:ext cx="2052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4443480" y="2198520"/>
            <a:ext cx="8424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3865680" y="2198520"/>
            <a:ext cx="7128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5678640" y="2198520"/>
            <a:ext cx="936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5511960" y="2057400"/>
            <a:ext cx="936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5499000" y="2198520"/>
            <a:ext cx="972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4960800" y="2057400"/>
            <a:ext cx="6840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4400640" y="2198520"/>
            <a:ext cx="9360" cy="12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6324480" y="2198520"/>
            <a:ext cx="138240" cy="12240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 rot="16200000">
            <a:off x="5975640" y="1596600"/>
            <a:ext cx="7963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RNA-Me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ns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 rot="16200000">
            <a:off x="4377960" y="1406160"/>
            <a:ext cx="9151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OG-Suf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OG-GrxC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 rot="16200000">
            <a:off x="2624760" y="1465200"/>
            <a:ext cx="112284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ORF97 (ORFan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ysozym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 rot="16200000">
            <a:off x="1994400" y="1544040"/>
            <a:ext cx="76284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G-Emr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G-Emr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 rot="16200000">
            <a:off x="1702080" y="1625400"/>
            <a:ext cx="835920" cy="38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G-Gu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G-Hc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 rot="16200000">
            <a:off x="1154880" y="1625760"/>
            <a:ext cx="88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titox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NA bind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 flipV="1">
            <a:off x="685800" y="2362320"/>
            <a:ext cx="5181480" cy="495360"/>
          </a:xfrm>
          <a:prstGeom prst="line">
            <a:avLst/>
          </a:prstGeom>
          <a:ln w="9360">
            <a:solidFill>
              <a:srgbClr val="000000"/>
            </a:solidFill>
            <a:prstDash val="lgDash"/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 flipV="1">
            <a:off x="228600" y="3728520"/>
            <a:ext cx="3200400" cy="324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3086280" y="3754440"/>
            <a:ext cx="13176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3370320" y="3754440"/>
            <a:ext cx="38160" cy="131760"/>
          </a:xfrm>
          <a:prstGeom prst="rect">
            <a:avLst/>
          </a:prstGeom>
          <a:solidFill>
            <a:srgbClr val="2002f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271440" y="3587760"/>
            <a:ext cx="32076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919080" y="3754440"/>
            <a:ext cx="3816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620640" y="3587760"/>
            <a:ext cx="1908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641520" y="3754440"/>
            <a:ext cx="80640" cy="13176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739800" y="3754440"/>
            <a:ext cx="3816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781200" y="3754440"/>
            <a:ext cx="3636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1100160" y="3754440"/>
            <a:ext cx="824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1197000" y="3754440"/>
            <a:ext cx="13500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1353960" y="3587760"/>
            <a:ext cx="1908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1384200" y="3754440"/>
            <a:ext cx="3816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817560" y="3754440"/>
            <a:ext cx="3816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1050840" y="3754440"/>
            <a:ext cx="4932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1446120" y="3754440"/>
            <a:ext cx="3672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1557360" y="3754440"/>
            <a:ext cx="36360" cy="13176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1530360" y="3754440"/>
            <a:ext cx="1908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1631880" y="3587760"/>
            <a:ext cx="1908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1655640" y="3587760"/>
            <a:ext cx="590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1717560" y="3587760"/>
            <a:ext cx="6372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1843200" y="3587760"/>
            <a:ext cx="410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1879560" y="3587760"/>
            <a:ext cx="1908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3303720" y="3587760"/>
            <a:ext cx="5076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3268800" y="3587760"/>
            <a:ext cx="1908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2889360" y="3587760"/>
            <a:ext cx="428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811600" y="3754440"/>
            <a:ext cx="1908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1920960" y="3754440"/>
            <a:ext cx="428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1957320" y="3754440"/>
            <a:ext cx="1908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2011320" y="3587760"/>
            <a:ext cx="1908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2030400" y="3754440"/>
            <a:ext cx="3816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2139840" y="3587760"/>
            <a:ext cx="4140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2060640" y="3587760"/>
            <a:ext cx="428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2101680" y="3587760"/>
            <a:ext cx="3816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2206800" y="3754440"/>
            <a:ext cx="428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2255760" y="3754440"/>
            <a:ext cx="6192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2351160" y="3587760"/>
            <a:ext cx="410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2387520" y="3587760"/>
            <a:ext cx="1908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2446200" y="3754440"/>
            <a:ext cx="428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2495520" y="3754440"/>
            <a:ext cx="4464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2678040" y="3754440"/>
            <a:ext cx="428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2727360" y="3754440"/>
            <a:ext cx="61920" cy="131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2552760" y="3754440"/>
            <a:ext cx="106200" cy="131760"/>
          </a:xfrm>
          <a:prstGeom prst="rect">
            <a:avLst/>
          </a:prstGeom>
          <a:solidFill>
            <a:srgbClr val="ffff0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2843280" y="3587760"/>
            <a:ext cx="410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2928960" y="3587760"/>
            <a:ext cx="28440" cy="131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V="1">
            <a:off x="3416400" y="3722400"/>
            <a:ext cx="3124080" cy="1116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4889520" y="3600360"/>
            <a:ext cx="11412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4664160" y="3600360"/>
            <a:ext cx="6984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4807080" y="3600360"/>
            <a:ext cx="4428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5070600" y="3600360"/>
            <a:ext cx="393480" cy="12060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5465880" y="3600360"/>
            <a:ext cx="42840" cy="12060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5772240" y="3746520"/>
            <a:ext cx="11412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4284720" y="3600360"/>
            <a:ext cx="120600" cy="12060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6257880" y="3600360"/>
            <a:ext cx="184320" cy="120600"/>
          </a:xfrm>
          <a:prstGeom prst="rect">
            <a:avLst/>
          </a:prstGeom>
          <a:solidFill>
            <a:srgbClr val="ffff0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6478560" y="3746520"/>
            <a:ext cx="20520" cy="12060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3745080" y="3600360"/>
            <a:ext cx="242640" cy="120600"/>
          </a:xfrm>
          <a:prstGeom prst="rect">
            <a:avLst/>
          </a:prstGeom>
          <a:solidFill>
            <a:srgbClr val="ffff0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3652920" y="3746520"/>
            <a:ext cx="7308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3606840" y="3746520"/>
            <a:ext cx="4932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3570120" y="3600360"/>
            <a:ext cx="1764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4406760" y="3600360"/>
            <a:ext cx="239760" cy="120600"/>
          </a:xfrm>
          <a:prstGeom prst="rect">
            <a:avLst/>
          </a:prstGeom>
          <a:solidFill>
            <a:srgbClr val="ffff0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4740120" y="3600360"/>
            <a:ext cx="5724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5546880" y="3746520"/>
            <a:ext cx="8244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5506920" y="3600360"/>
            <a:ext cx="17640" cy="12060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5630760" y="3746520"/>
            <a:ext cx="11124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5897520" y="3746520"/>
            <a:ext cx="3960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5938920" y="3746520"/>
            <a:ext cx="95040" cy="12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6054840" y="3746520"/>
            <a:ext cx="19080" cy="12060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6083280" y="3746520"/>
            <a:ext cx="114480" cy="12060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6213600" y="3746520"/>
            <a:ext cx="41040" cy="12060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 rot="16200000">
            <a:off x="6081120" y="4085640"/>
            <a:ext cx="779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RNA-S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 rot="16200000">
            <a:off x="2879640" y="3311640"/>
            <a:ext cx="55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G-Soj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 rot="16200000">
            <a:off x="2639520" y="313344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G-54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 rot="16200000">
            <a:off x="99720" y="312408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G-396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 rot="16200000">
            <a:off x="1150200" y="307512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pha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intena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 rot="16200000">
            <a:off x="2379240" y="3201840"/>
            <a:ext cx="650160" cy="38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ysozy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G-44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 rot="16200000">
            <a:off x="2014200" y="2993400"/>
            <a:ext cx="8528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irulenc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soci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 rot="16200000">
            <a:off x="6050160" y="3897000"/>
            <a:ext cx="55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gr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 rot="18900000">
            <a:off x="4375080" y="3107880"/>
            <a:ext cx="95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arge termin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 rot="18900000">
            <a:off x="4155840" y="3074760"/>
            <a:ext cx="111204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NAP sigma fac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 rot="18900000">
            <a:off x="3693960" y="3107880"/>
            <a:ext cx="108000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F25 - structur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 rot="16200000">
            <a:off x="3325320" y="4062960"/>
            <a:ext cx="68220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 algn="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titox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NA bindin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7" name=""/>
          <p:cNvGrpSpPr/>
          <p:nvPr/>
        </p:nvGrpSpPr>
        <p:grpSpPr>
          <a:xfrm>
            <a:off x="3505320" y="592200"/>
            <a:ext cx="139680" cy="514080"/>
            <a:chOff x="3505320" y="592200"/>
            <a:chExt cx="139680" cy="514080"/>
          </a:xfrm>
        </p:grpSpPr>
        <p:sp>
          <p:nvSpPr>
            <p:cNvPr id="358" name=""/>
            <p:cNvSpPr/>
            <p:nvPr/>
          </p:nvSpPr>
          <p:spPr>
            <a:xfrm>
              <a:off x="3505320" y="592200"/>
              <a:ext cx="139680" cy="135360"/>
            </a:xfrm>
            <a:prstGeom prst="rect">
              <a:avLst/>
            </a:prstGeom>
            <a:solidFill>
              <a:srgbClr val="fc700b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3505320" y="781200"/>
              <a:ext cx="139680" cy="135720"/>
            </a:xfrm>
            <a:prstGeom prst="rect">
              <a:avLst/>
            </a:prstGeom>
            <a:solidFill>
              <a:srgbClr val="ffff08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3505320" y="970560"/>
              <a:ext cx="139680" cy="135720"/>
            </a:xfrm>
            <a:prstGeom prst="rect">
              <a:avLst/>
            </a:prstGeom>
            <a:solidFill>
              <a:srgbClr val="041ef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1" name=""/>
          <p:cNvSpPr/>
          <p:nvPr/>
        </p:nvSpPr>
        <p:spPr>
          <a:xfrm>
            <a:off x="3611520" y="533520"/>
            <a:ext cx="27500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ossible prophage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phage gene similar to P-SS2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posas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 rot="16200000">
            <a:off x="5666040" y="3014280"/>
            <a:ext cx="1029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phage anti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press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3600" y="228600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,494,4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6184800" y="234648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,535,2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40320" y="3809880"/>
            <a:ext cx="579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" rIns="9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,562,6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6394680" y="3403440"/>
            <a:ext cx="42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,1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 rot="16200000">
            <a:off x="134640" y="1526040"/>
            <a:ext cx="80856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redox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ermeas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 rot="16200000">
            <a:off x="-106560" y="1626840"/>
            <a:ext cx="97920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_1322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 rot="16200000">
            <a:off x="2915640" y="1525320"/>
            <a:ext cx="97920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_134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 rot="16200000">
            <a:off x="3296520" y="1525320"/>
            <a:ext cx="97920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_134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 rot="16200000">
            <a:off x="3571560" y="1792440"/>
            <a:ext cx="69588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G34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 rot="16200000">
            <a:off x="3952800" y="1658880"/>
            <a:ext cx="73404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G-119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 rot="16200000">
            <a:off x="4244760" y="1782360"/>
            <a:ext cx="70488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thylas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 rot="16200000">
            <a:off x="3653280" y="1452240"/>
            <a:ext cx="98676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AD52 - DNA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pai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 rot="16200000">
            <a:off x="4731120" y="1541160"/>
            <a:ext cx="808560" cy="36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redox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inas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 rot="16200000">
            <a:off x="781920" y="3335400"/>
            <a:ext cx="63036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AD5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 rot="16200000">
            <a:off x="2931480" y="3193200"/>
            <a:ext cx="97920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_139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 rot="16200000">
            <a:off x="3104280" y="3064680"/>
            <a:ext cx="97920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_000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 flipV="1">
            <a:off x="3352680" y="3733920"/>
            <a:ext cx="15264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2960640" y="4137120"/>
            <a:ext cx="636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eno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ar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2519640" y="3886200"/>
            <a:ext cx="83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lational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presso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2871720" y="3733920"/>
            <a:ext cx="33480" cy="193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 rot="16200000">
            <a:off x="309240" y="3256560"/>
            <a:ext cx="81936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ethylas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4576680" y="4017960"/>
            <a:ext cx="1621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anscriptional regulator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ssible repress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 flipH="1">
            <a:off x="5325840" y="3878280"/>
            <a:ext cx="888840" cy="17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6" name="" descr=""/>
          <p:cNvPicPr/>
          <p:nvPr/>
        </p:nvPicPr>
        <p:blipFill>
          <a:blip r:embed="rId1"/>
          <a:stretch/>
        </p:blipFill>
        <p:spPr>
          <a:xfrm>
            <a:off x="228600" y="1143000"/>
            <a:ext cx="6629400" cy="3730680"/>
          </a:xfrm>
          <a:prstGeom prst="rect">
            <a:avLst/>
          </a:prstGeom>
          <a:ln w="0">
            <a:noFill/>
          </a:ln>
        </p:spPr>
      </p:pic>
      <p:sp>
        <p:nvSpPr>
          <p:cNvPr id="387" name=""/>
          <p:cNvSpPr/>
          <p:nvPr/>
        </p:nvSpPr>
        <p:spPr>
          <a:xfrm>
            <a:off x="152280" y="1295280"/>
            <a:ext cx="495324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IS element classifications in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Synechococcus</a:t>
            </a:r>
            <a:r>
              <a:rPr b="0" i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 RS9917 genom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1"/>
          <p:cNvSpPr>
            <a:spLocks noGrp="1"/>
          </p:cNvSpPr>
          <p:nvPr>
            <p:ph type="title"/>
          </p:nvPr>
        </p:nvSpPr>
        <p:spPr>
          <a:xfrm>
            <a:off x="228240" y="914040"/>
            <a:ext cx="1676520" cy="228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gure 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" name="PlaceHolder 1"/>
          <p:cNvSpPr>
            <a:spLocks noGrp="1"/>
          </p:cNvSpPr>
          <p:nvPr>
            <p:ph type="title"/>
          </p:nvPr>
        </p:nvSpPr>
        <p:spPr>
          <a:xfrm>
            <a:off x="152280" y="380880"/>
            <a:ext cx="2533680" cy="33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6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773280" y="2048040"/>
            <a:ext cx="5738760" cy="936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811080" y="2057400"/>
            <a:ext cx="115920" cy="100080"/>
          </a:xfrm>
          <a:prstGeom prst="rect">
            <a:avLst/>
          </a:prstGeom>
          <a:solidFill>
            <a:srgbClr val="00999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1782720" y="2057400"/>
            <a:ext cx="378000" cy="100080"/>
          </a:xfrm>
          <a:prstGeom prst="rect">
            <a:avLst/>
          </a:prstGeom>
          <a:solidFill>
            <a:srgbClr val="82e3d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947880" y="2057400"/>
            <a:ext cx="295200" cy="100080"/>
          </a:xfrm>
          <a:prstGeom prst="rect">
            <a:avLst/>
          </a:prstGeom>
          <a:solidFill>
            <a:srgbClr val="33339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1604880" y="1928880"/>
            <a:ext cx="77760" cy="10008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1685880" y="1928880"/>
            <a:ext cx="79560" cy="100080"/>
          </a:xfrm>
          <a:prstGeom prst="rect">
            <a:avLst/>
          </a:prstGeom>
          <a:solidFill>
            <a:srgbClr val="82e3d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3278160" y="2057400"/>
            <a:ext cx="347760" cy="100080"/>
          </a:xfrm>
          <a:prstGeom prst="rect">
            <a:avLst/>
          </a:prstGeom>
          <a:solidFill>
            <a:srgbClr val="c6464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1273320" y="2057400"/>
            <a:ext cx="261720" cy="100080"/>
          </a:xfrm>
          <a:prstGeom prst="rect">
            <a:avLst/>
          </a:prstGeom>
          <a:solidFill>
            <a:srgbClr val="ecc86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2395440" y="1928880"/>
            <a:ext cx="344520" cy="100080"/>
          </a:xfrm>
          <a:prstGeom prst="rect">
            <a:avLst/>
          </a:prstGeom>
          <a:solidFill>
            <a:srgbClr val="3d3355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2182680" y="1928880"/>
            <a:ext cx="187560" cy="10008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2773440" y="1928880"/>
            <a:ext cx="279360" cy="100080"/>
          </a:xfrm>
          <a:prstGeom prst="rect">
            <a:avLst/>
          </a:prstGeom>
          <a:solidFill>
            <a:srgbClr val="85006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3100320" y="1928880"/>
            <a:ext cx="131760" cy="100080"/>
          </a:xfrm>
          <a:prstGeom prst="rect">
            <a:avLst/>
          </a:prstGeom>
          <a:solidFill>
            <a:srgbClr val="9b87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3670200" y="1928880"/>
            <a:ext cx="146160" cy="100080"/>
          </a:xfrm>
          <a:prstGeom prst="rect">
            <a:avLst/>
          </a:prstGeom>
          <a:solidFill>
            <a:srgbClr val="ffc7f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5415120" y="2057400"/>
            <a:ext cx="3168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5586480" y="1928880"/>
            <a:ext cx="174600" cy="100080"/>
          </a:xfrm>
          <a:prstGeom prst="rect">
            <a:avLst/>
          </a:prstGeom>
          <a:solidFill>
            <a:srgbClr val="bbe0e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3832200" y="2057400"/>
            <a:ext cx="68400" cy="100080"/>
          </a:xfrm>
          <a:prstGeom prst="rect">
            <a:avLst/>
          </a:prstGeom>
          <a:solidFill>
            <a:srgbClr val="eca95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1547640" y="2057400"/>
            <a:ext cx="3024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4282920" y="2057400"/>
            <a:ext cx="177840" cy="100080"/>
          </a:xfrm>
          <a:prstGeom prst="rect">
            <a:avLst/>
          </a:prstGeom>
          <a:solidFill>
            <a:srgbClr val="c0873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4827600" y="2057400"/>
            <a:ext cx="228600" cy="100080"/>
          </a:xfrm>
          <a:prstGeom prst="rect">
            <a:avLst/>
          </a:prstGeom>
          <a:solidFill>
            <a:srgbClr val="215cc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4473720" y="1928880"/>
            <a:ext cx="260280" cy="100080"/>
          </a:xfrm>
          <a:prstGeom prst="rect">
            <a:avLst/>
          </a:prstGeom>
          <a:solidFill>
            <a:srgbClr val="f5120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5079960" y="2057400"/>
            <a:ext cx="308160" cy="100080"/>
          </a:xfrm>
          <a:prstGeom prst="rect">
            <a:avLst/>
          </a:prstGeom>
          <a:solidFill>
            <a:srgbClr val="3eb8b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5450040" y="1928880"/>
            <a:ext cx="112680" cy="100080"/>
          </a:xfrm>
          <a:prstGeom prst="rect">
            <a:avLst/>
          </a:prstGeom>
          <a:solidFill>
            <a:srgbClr val="2b2b8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3971880" y="1928880"/>
            <a:ext cx="268200" cy="100080"/>
          </a:xfrm>
          <a:prstGeom prst="rect">
            <a:avLst/>
          </a:prstGeom>
          <a:solidFill>
            <a:srgbClr val="bbe0e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4756320" y="1928880"/>
            <a:ext cx="29880" cy="100080"/>
          </a:xfrm>
          <a:prstGeom prst="rect">
            <a:avLst/>
          </a:prstGeom>
          <a:solidFill>
            <a:srgbClr val="9affd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5830920" y="2057400"/>
            <a:ext cx="323640" cy="100080"/>
          </a:xfrm>
          <a:prstGeom prst="rect">
            <a:avLst/>
          </a:prstGeom>
          <a:solidFill>
            <a:srgbClr val="fbf0b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6189840" y="1928880"/>
            <a:ext cx="249120" cy="100080"/>
          </a:xfrm>
          <a:prstGeom prst="rect">
            <a:avLst/>
          </a:prstGeom>
          <a:solidFill>
            <a:srgbClr val="d966d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285120" y="193356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46,18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6297120" y="204156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68,68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3917880" y="1928880"/>
            <a:ext cx="3024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320400" y="1371600"/>
            <a:ext cx="7628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ProMED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+ 9 othe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enome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 rot="16200000">
            <a:off x="891360" y="1245960"/>
            <a:ext cx="918360" cy="732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i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ly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NA-Ar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 rot="16200000">
            <a:off x="1747800" y="1609560"/>
            <a:ext cx="52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v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 rot="16200000">
            <a:off x="2273760" y="920880"/>
            <a:ext cx="878760" cy="11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fs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mt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yt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. hy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 rot="16200000">
            <a:off x="3188880" y="1676160"/>
            <a:ext cx="51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ec0b08"/>
                </a:solidFill>
                <a:latin typeface="Arial"/>
              </a:rPr>
              <a:t>pur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 rot="16200000">
            <a:off x="3526200" y="1243080"/>
            <a:ext cx="767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ster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 rot="16200000">
            <a:off x="4426560" y="16725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g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 rot="16200000">
            <a:off x="4802400" y="1530720"/>
            <a:ext cx="54360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vi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ly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 rot="16200000">
            <a:off x="5199840" y="1354320"/>
            <a:ext cx="784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ec0b08"/>
                </a:solidFill>
                <a:latin typeface="Arial"/>
              </a:rPr>
              <a:t>py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G35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 rot="16200000">
            <a:off x="5573880" y="1478880"/>
            <a:ext cx="86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G225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 rot="16200000">
            <a:off x="6066360" y="147456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an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766800" y="3219480"/>
            <a:ext cx="5738760" cy="936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806400" y="3228840"/>
            <a:ext cx="378000" cy="100080"/>
          </a:xfrm>
          <a:prstGeom prst="rect">
            <a:avLst/>
          </a:prstGeom>
          <a:solidFill>
            <a:srgbClr val="82e3d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2209680" y="3228840"/>
            <a:ext cx="347760" cy="100080"/>
          </a:xfrm>
          <a:prstGeom prst="rect">
            <a:avLst/>
          </a:prstGeom>
          <a:solidFill>
            <a:srgbClr val="c6464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1419120" y="3100320"/>
            <a:ext cx="344520" cy="100080"/>
          </a:xfrm>
          <a:prstGeom prst="rect">
            <a:avLst/>
          </a:prstGeom>
          <a:solidFill>
            <a:srgbClr val="3d3355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1206360" y="3100320"/>
            <a:ext cx="187560" cy="10008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1797120" y="3100320"/>
            <a:ext cx="279360" cy="100080"/>
          </a:xfrm>
          <a:prstGeom prst="rect">
            <a:avLst/>
          </a:prstGeom>
          <a:solidFill>
            <a:srgbClr val="85006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2057400" y="3100320"/>
            <a:ext cx="131760" cy="100080"/>
          </a:xfrm>
          <a:prstGeom prst="rect">
            <a:avLst/>
          </a:prstGeom>
          <a:solidFill>
            <a:srgbClr val="9b87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2602080" y="3100320"/>
            <a:ext cx="145800" cy="100080"/>
          </a:xfrm>
          <a:prstGeom prst="rect">
            <a:avLst/>
          </a:prstGeom>
          <a:solidFill>
            <a:srgbClr val="ffc7f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5316480" y="3228840"/>
            <a:ext cx="3168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5627520" y="3100320"/>
            <a:ext cx="174960" cy="100080"/>
          </a:xfrm>
          <a:prstGeom prst="rect">
            <a:avLst/>
          </a:prstGeom>
          <a:solidFill>
            <a:srgbClr val="bbe0e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2763720" y="3228840"/>
            <a:ext cx="68400" cy="100080"/>
          </a:xfrm>
          <a:prstGeom prst="rect">
            <a:avLst/>
          </a:prstGeom>
          <a:solidFill>
            <a:srgbClr val="eca95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3214800" y="3228840"/>
            <a:ext cx="177840" cy="100080"/>
          </a:xfrm>
          <a:prstGeom prst="rect">
            <a:avLst/>
          </a:prstGeom>
          <a:solidFill>
            <a:srgbClr val="c0873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4729320" y="3228840"/>
            <a:ext cx="228600" cy="100080"/>
          </a:xfrm>
          <a:prstGeom prst="rect">
            <a:avLst/>
          </a:prstGeom>
          <a:solidFill>
            <a:srgbClr val="215cc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3405240" y="3100320"/>
            <a:ext cx="260280" cy="100080"/>
          </a:xfrm>
          <a:prstGeom prst="rect">
            <a:avLst/>
          </a:prstGeom>
          <a:solidFill>
            <a:srgbClr val="f5120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4981680" y="3228840"/>
            <a:ext cx="307800" cy="100080"/>
          </a:xfrm>
          <a:prstGeom prst="rect">
            <a:avLst/>
          </a:prstGeom>
          <a:solidFill>
            <a:srgbClr val="3eb8b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5491080" y="3100320"/>
            <a:ext cx="112680" cy="100080"/>
          </a:xfrm>
          <a:prstGeom prst="rect">
            <a:avLst/>
          </a:prstGeom>
          <a:solidFill>
            <a:srgbClr val="2b2b8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2903400" y="3100320"/>
            <a:ext cx="268560" cy="100080"/>
          </a:xfrm>
          <a:prstGeom prst="rect">
            <a:avLst/>
          </a:prstGeom>
          <a:solidFill>
            <a:srgbClr val="bbe0e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3687840" y="3100320"/>
            <a:ext cx="30240" cy="100080"/>
          </a:xfrm>
          <a:prstGeom prst="rect">
            <a:avLst/>
          </a:prstGeom>
          <a:solidFill>
            <a:srgbClr val="9affd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5824440" y="3228840"/>
            <a:ext cx="324000" cy="100080"/>
          </a:xfrm>
          <a:prstGeom prst="rect">
            <a:avLst/>
          </a:prstGeom>
          <a:solidFill>
            <a:srgbClr val="fbf0b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6183360" y="3100320"/>
            <a:ext cx="249120" cy="100080"/>
          </a:xfrm>
          <a:prstGeom prst="rect">
            <a:avLst/>
          </a:prstGeom>
          <a:solidFill>
            <a:srgbClr val="d966d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285120" y="308448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33,97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2849400" y="3100320"/>
            <a:ext cx="3024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6305040" y="318456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6,47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3946680" y="3098880"/>
            <a:ext cx="761760" cy="10008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3749760" y="3227400"/>
            <a:ext cx="177840" cy="100080"/>
          </a:xfrm>
          <a:prstGeom prst="rect">
            <a:avLst/>
          </a:prstGeom>
          <a:solidFill>
            <a:srgbClr val="d3c93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221040" y="2819520"/>
            <a:ext cx="206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SynWH810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(+ 8 other genome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5372280" y="3228840"/>
            <a:ext cx="104760" cy="10980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773280" y="2614680"/>
            <a:ext cx="5738760" cy="936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1108080" y="2624040"/>
            <a:ext cx="378000" cy="100080"/>
          </a:xfrm>
          <a:prstGeom prst="rect">
            <a:avLst/>
          </a:prstGeom>
          <a:solidFill>
            <a:srgbClr val="82e3d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930240" y="2495520"/>
            <a:ext cx="77760" cy="10008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1011240" y="2495520"/>
            <a:ext cx="79200" cy="100080"/>
          </a:xfrm>
          <a:prstGeom prst="rect">
            <a:avLst/>
          </a:prstGeom>
          <a:solidFill>
            <a:srgbClr val="82e3d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2892600" y="2624040"/>
            <a:ext cx="347400" cy="100080"/>
          </a:xfrm>
          <a:prstGeom prst="rect">
            <a:avLst/>
          </a:prstGeom>
          <a:solidFill>
            <a:srgbClr val="c6464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1752480" y="2495520"/>
            <a:ext cx="344520" cy="100080"/>
          </a:xfrm>
          <a:prstGeom prst="rect">
            <a:avLst/>
          </a:prstGeom>
          <a:solidFill>
            <a:srgbClr val="3d3355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1508040" y="2495520"/>
            <a:ext cx="187560" cy="10008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2158920" y="2495520"/>
            <a:ext cx="279360" cy="100080"/>
          </a:xfrm>
          <a:prstGeom prst="rect">
            <a:avLst/>
          </a:prstGeom>
          <a:solidFill>
            <a:srgbClr val="85006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2714760" y="2495520"/>
            <a:ext cx="131760" cy="100080"/>
          </a:xfrm>
          <a:prstGeom prst="rect">
            <a:avLst/>
          </a:prstGeom>
          <a:solidFill>
            <a:srgbClr val="9b87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3284640" y="2495520"/>
            <a:ext cx="145800" cy="100080"/>
          </a:xfrm>
          <a:prstGeom prst="rect">
            <a:avLst/>
          </a:prstGeom>
          <a:solidFill>
            <a:srgbClr val="ffc7f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5586480" y="2495520"/>
            <a:ext cx="174600" cy="100080"/>
          </a:xfrm>
          <a:prstGeom prst="rect">
            <a:avLst/>
          </a:prstGeom>
          <a:solidFill>
            <a:srgbClr val="bbe0e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3446640" y="2624040"/>
            <a:ext cx="68040" cy="100080"/>
          </a:xfrm>
          <a:prstGeom prst="rect">
            <a:avLst/>
          </a:prstGeom>
          <a:solidFill>
            <a:srgbClr val="eca95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3897360" y="2624040"/>
            <a:ext cx="177840" cy="100080"/>
          </a:xfrm>
          <a:prstGeom prst="rect">
            <a:avLst/>
          </a:prstGeom>
          <a:solidFill>
            <a:srgbClr val="c0873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4643280" y="2624040"/>
            <a:ext cx="228600" cy="100080"/>
          </a:xfrm>
          <a:prstGeom prst="rect">
            <a:avLst/>
          </a:prstGeom>
          <a:solidFill>
            <a:srgbClr val="215cc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4087800" y="2495520"/>
            <a:ext cx="260280" cy="100080"/>
          </a:xfrm>
          <a:prstGeom prst="rect">
            <a:avLst/>
          </a:prstGeom>
          <a:solidFill>
            <a:srgbClr val="f5120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4896000" y="2624040"/>
            <a:ext cx="307800" cy="100080"/>
          </a:xfrm>
          <a:prstGeom prst="rect">
            <a:avLst/>
          </a:prstGeom>
          <a:solidFill>
            <a:srgbClr val="3eb8bc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5450040" y="2495520"/>
            <a:ext cx="112680" cy="100080"/>
          </a:xfrm>
          <a:prstGeom prst="rect">
            <a:avLst/>
          </a:prstGeom>
          <a:solidFill>
            <a:srgbClr val="2b2b8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3586320" y="2495520"/>
            <a:ext cx="268200" cy="100080"/>
          </a:xfrm>
          <a:prstGeom prst="rect">
            <a:avLst/>
          </a:prstGeom>
          <a:solidFill>
            <a:srgbClr val="bbe0e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4370400" y="2495520"/>
            <a:ext cx="30240" cy="100080"/>
          </a:xfrm>
          <a:prstGeom prst="rect">
            <a:avLst/>
          </a:prstGeom>
          <a:solidFill>
            <a:srgbClr val="9affd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5830920" y="2624040"/>
            <a:ext cx="323640" cy="100080"/>
          </a:xfrm>
          <a:prstGeom prst="rect">
            <a:avLst/>
          </a:prstGeom>
          <a:solidFill>
            <a:srgbClr val="fbf0b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6189840" y="2495520"/>
            <a:ext cx="249120" cy="100080"/>
          </a:xfrm>
          <a:prstGeom prst="rect">
            <a:avLst/>
          </a:prstGeom>
          <a:solidFill>
            <a:srgbClr val="d966d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3532320" y="2495520"/>
            <a:ext cx="2988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2117880" y="2647800"/>
            <a:ext cx="2988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1704960" y="2647800"/>
            <a:ext cx="3024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2492280" y="2495520"/>
            <a:ext cx="146160" cy="10008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4430880" y="2622600"/>
            <a:ext cx="177480" cy="100080"/>
          </a:xfrm>
          <a:prstGeom prst="rect">
            <a:avLst/>
          </a:prstGeom>
          <a:solidFill>
            <a:srgbClr val="d3c93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5268960" y="2624040"/>
            <a:ext cx="146160" cy="10008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365040" y="2533680"/>
            <a:ext cx="18432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102240" y="251460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,956,32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6134760" y="262404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,978,82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228240" y="2257560"/>
            <a:ext cx="198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ProMIT931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(+ 1 other genom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606240" y="3429000"/>
            <a:ext cx="85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SynRS99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1932120" y="3755880"/>
            <a:ext cx="4570200" cy="972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2419200" y="3765600"/>
            <a:ext cx="187560" cy="9216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2108160" y="3760920"/>
            <a:ext cx="279360" cy="9036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2951280" y="3765600"/>
            <a:ext cx="145800" cy="10008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5334120" y="3765600"/>
            <a:ext cx="3168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5645160" y="3637080"/>
            <a:ext cx="174600" cy="99720"/>
          </a:xfrm>
          <a:prstGeom prst="rect">
            <a:avLst/>
          </a:prstGeom>
          <a:solidFill>
            <a:srgbClr val="bbe0e3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3149640" y="3765600"/>
            <a:ext cx="68400" cy="10008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3395520" y="3638520"/>
            <a:ext cx="127080" cy="10008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3514680" y="3637080"/>
            <a:ext cx="260280" cy="9972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5041800" y="3765600"/>
            <a:ext cx="265320" cy="10800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5508720" y="3637080"/>
            <a:ext cx="112680" cy="99720"/>
          </a:xfrm>
          <a:prstGeom prst="rect">
            <a:avLst/>
          </a:prstGeom>
          <a:solidFill>
            <a:srgbClr val="2b2b8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2751120" y="3765600"/>
            <a:ext cx="201600" cy="10152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3808440" y="3773520"/>
            <a:ext cx="156960" cy="10008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5842080" y="3765600"/>
            <a:ext cx="323640" cy="100080"/>
          </a:xfrm>
          <a:prstGeom prst="rect">
            <a:avLst/>
          </a:prstGeom>
          <a:solidFill>
            <a:srgbClr val="fbf0b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6200640" y="3637080"/>
            <a:ext cx="249480" cy="99720"/>
          </a:xfrm>
          <a:prstGeom prst="rect">
            <a:avLst/>
          </a:prstGeom>
          <a:solidFill>
            <a:srgbClr val="d966d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6274800" y="374508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68,6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4191120" y="3773520"/>
            <a:ext cx="703080" cy="10944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3971880" y="3772080"/>
            <a:ext cx="160560" cy="9972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5389560" y="3765600"/>
            <a:ext cx="104760" cy="10944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818640" y="364500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0,9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2124360" y="4089240"/>
            <a:ext cx="2513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enomic island region, detailed in Fig. 6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 flipV="1" rot="5400000">
            <a:off x="3264840" y="2106360"/>
            <a:ext cx="199800" cy="3833640"/>
          </a:xfrm>
          <a:custGeom>
            <a:avLst/>
            <a:gdLst>
              <a:gd name="textAreaLeft" fmla="*/ 0 w 199800"/>
              <a:gd name="textAreaRight" fmla="*/ 72000 w 199800"/>
              <a:gd name="textAreaTop" fmla="*/ 99720 h 3833640"/>
              <a:gd name="textAreaBottom" fmla="*/ 3733920 h 3833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 rot="16200000">
            <a:off x="4290480" y="2269440"/>
            <a:ext cx="4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ff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 rot="16200000">
            <a:off x="2346840" y="221112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y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 rot="16200000">
            <a:off x="5113800" y="232884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y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 rot="16200000">
            <a:off x="4072680" y="281304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y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 rot="16200000">
            <a:off x="5191560" y="293688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y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 rot="16200000">
            <a:off x="3604680" y="2912400"/>
            <a:ext cx="4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ff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 rot="16200000">
            <a:off x="4100760" y="167940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ec0b08"/>
                </a:solidFill>
                <a:latin typeface="Arial"/>
              </a:rPr>
              <a:t>cob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5029200" y="4091040"/>
            <a:ext cx="18288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NA-Met +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py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 hot-spot for IS elements in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ynechococcus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99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 flipH="1" flipV="1">
            <a:off x="5575320" y="3809520"/>
            <a:ext cx="6336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1344600" y="3757680"/>
            <a:ext cx="439920" cy="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1411200" y="3786120"/>
            <a:ext cx="279360" cy="90720"/>
          </a:xfrm>
          <a:prstGeom prst="rect">
            <a:avLst/>
          </a:prstGeom>
          <a:solidFill>
            <a:srgbClr val="a9a9a9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2" name=""/>
          <p:cNvGrpSpPr/>
          <p:nvPr/>
        </p:nvGrpSpPr>
        <p:grpSpPr>
          <a:xfrm>
            <a:off x="1784520" y="3565080"/>
            <a:ext cx="155520" cy="365400"/>
            <a:chOff x="1784520" y="3565080"/>
            <a:chExt cx="155520" cy="365400"/>
          </a:xfrm>
        </p:grpSpPr>
        <p:sp>
          <p:nvSpPr>
            <p:cNvPr id="523" name=""/>
            <p:cNvSpPr/>
            <p:nvPr/>
          </p:nvSpPr>
          <p:spPr>
            <a:xfrm flipV="1">
              <a:off x="1784520" y="3565080"/>
              <a:ext cx="69840" cy="228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 flipV="1">
              <a:off x="1879920" y="3735360"/>
              <a:ext cx="60120" cy="1951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 flipH="1" flipV="1">
              <a:off x="1855440" y="3584160"/>
              <a:ext cx="16200" cy="34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6" name=""/>
          <p:cNvSpPr/>
          <p:nvPr/>
        </p:nvSpPr>
        <p:spPr>
          <a:xfrm>
            <a:off x="1652040" y="338472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~44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PlaceHolder 1"/>
          <p:cNvSpPr>
            <a:spLocks noGrp="1"/>
          </p:cNvSpPr>
          <p:nvPr>
            <p:ph type="title"/>
          </p:nvPr>
        </p:nvSpPr>
        <p:spPr>
          <a:xfrm>
            <a:off x="228240" y="75960"/>
            <a:ext cx="1924200" cy="406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gure 6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90000" y="793800"/>
            <a:ext cx="217728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Synechococcu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RS9917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RNA-Met +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pyrE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 rot="16200000">
            <a:off x="2993400" y="1643040"/>
            <a:ext cx="68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G-Ddp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 rot="16200000">
            <a:off x="5817960" y="164304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G-49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 rot="16200000">
            <a:off x="457920" y="1643040"/>
            <a:ext cx="837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arg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rmin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2" name=""/>
          <p:cNvGrpSpPr/>
          <p:nvPr/>
        </p:nvGrpSpPr>
        <p:grpSpPr>
          <a:xfrm>
            <a:off x="301680" y="2133720"/>
            <a:ext cx="3432240" cy="261360"/>
            <a:chOff x="301680" y="2133720"/>
            <a:chExt cx="3432240" cy="261360"/>
          </a:xfrm>
        </p:grpSpPr>
        <p:sp>
          <p:nvSpPr>
            <p:cNvPr id="533" name=""/>
            <p:cNvSpPr/>
            <p:nvPr/>
          </p:nvSpPr>
          <p:spPr>
            <a:xfrm flipV="1">
              <a:off x="301680" y="2257560"/>
              <a:ext cx="3432240" cy="3960"/>
            </a:xfrm>
            <a:prstGeom prst="line">
              <a:avLst/>
            </a:prstGeom>
            <a:ln w="381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3128040" y="2275200"/>
              <a:ext cx="137160" cy="1152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345960" y="2278080"/>
              <a:ext cx="215640" cy="1152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1604880" y="2133720"/>
              <a:ext cx="161640" cy="1152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590040" y="2279880"/>
              <a:ext cx="97560" cy="1152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1119600" y="2279880"/>
              <a:ext cx="84600" cy="115200"/>
            </a:xfrm>
            <a:prstGeom prst="rect">
              <a:avLst/>
            </a:prstGeom>
            <a:solidFill>
              <a:srgbClr val="fc700b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1203480" y="2133720"/>
              <a:ext cx="241920" cy="115200"/>
            </a:xfrm>
            <a:prstGeom prst="rect">
              <a:avLst/>
            </a:prstGeom>
            <a:solidFill>
              <a:srgbClr val="041ef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1451880" y="2133720"/>
              <a:ext cx="88200" cy="115200"/>
            </a:xfrm>
            <a:prstGeom prst="rect">
              <a:avLst/>
            </a:prstGeom>
            <a:solidFill>
              <a:srgbClr val="041ef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3286440" y="2133720"/>
              <a:ext cx="88920" cy="1152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3375360" y="2135520"/>
              <a:ext cx="39960" cy="1152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2455920" y="2275200"/>
              <a:ext cx="109080" cy="1152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690480" y="2278080"/>
              <a:ext cx="378360" cy="115200"/>
            </a:xfrm>
            <a:prstGeom prst="rect">
              <a:avLst/>
            </a:prstGeom>
            <a:solidFill>
              <a:srgbClr val="ffff08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2140560" y="2274120"/>
              <a:ext cx="314280" cy="115200"/>
            </a:xfrm>
            <a:prstGeom prst="rect">
              <a:avLst/>
            </a:prstGeom>
            <a:solidFill>
              <a:srgbClr val="ffff08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1884240" y="2133720"/>
              <a:ext cx="206280" cy="115200"/>
            </a:xfrm>
            <a:prstGeom prst="rect">
              <a:avLst/>
            </a:prstGeom>
            <a:solidFill>
              <a:srgbClr val="ffff08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2593080" y="2275200"/>
              <a:ext cx="206280" cy="1152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2821320" y="2273040"/>
              <a:ext cx="170280" cy="115200"/>
            </a:xfrm>
            <a:prstGeom prst="rect">
              <a:avLst/>
            </a:prstGeom>
            <a:solidFill>
              <a:srgbClr val="ffff08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3011760" y="2273040"/>
              <a:ext cx="75240" cy="1152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3491640" y="2278080"/>
              <a:ext cx="209880" cy="115200"/>
            </a:xfrm>
            <a:prstGeom prst="rect">
              <a:avLst/>
            </a:prstGeom>
            <a:solidFill>
              <a:srgbClr val="ffff08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1" name=""/>
          <p:cNvSpPr/>
          <p:nvPr/>
        </p:nvSpPr>
        <p:spPr>
          <a:xfrm flipV="1">
            <a:off x="3733920" y="2257200"/>
            <a:ext cx="2895480" cy="468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"/>
          <p:cNvSpPr/>
          <p:nvPr/>
        </p:nvSpPr>
        <p:spPr>
          <a:xfrm>
            <a:off x="5573880" y="2146320"/>
            <a:ext cx="115560" cy="10152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>
            <a:off x="3746520" y="2273400"/>
            <a:ext cx="74520" cy="10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4435560" y="2273400"/>
            <a:ext cx="75960" cy="101520"/>
          </a:xfrm>
          <a:prstGeom prst="rect">
            <a:avLst/>
          </a:prstGeom>
          <a:solidFill>
            <a:srgbClr val="ffff0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4921200" y="2146320"/>
            <a:ext cx="33480" cy="1015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4214880" y="2273400"/>
            <a:ext cx="220680" cy="10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3906720" y="2273400"/>
            <a:ext cx="155520" cy="10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4687920" y="2273400"/>
            <a:ext cx="201600" cy="10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4514760" y="2273400"/>
            <a:ext cx="146160" cy="10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5099040" y="2273400"/>
            <a:ext cx="301680" cy="101520"/>
          </a:xfrm>
          <a:prstGeom prst="rect">
            <a:avLst/>
          </a:prstGeom>
          <a:solidFill>
            <a:srgbClr val="041ef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5408640" y="2273400"/>
            <a:ext cx="61920" cy="101520"/>
          </a:xfrm>
          <a:prstGeom prst="rect">
            <a:avLst/>
          </a:prstGeom>
          <a:solidFill>
            <a:srgbClr val="041ef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3814920" y="2273400"/>
            <a:ext cx="90360" cy="10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4056120" y="2273400"/>
            <a:ext cx="74520" cy="10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>
            <a:off x="5006880" y="2146320"/>
            <a:ext cx="33480" cy="1015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5735520" y="2146320"/>
            <a:ext cx="34920" cy="1015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5867280" y="2273400"/>
            <a:ext cx="34920" cy="1015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5929200" y="2146320"/>
            <a:ext cx="357480" cy="10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6288120" y="2146320"/>
            <a:ext cx="338040" cy="10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 rot="16200000">
            <a:off x="763200" y="1751760"/>
            <a:ext cx="72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gma fac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 rot="16200000">
            <a:off x="1694880" y="1633680"/>
            <a:ext cx="56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gr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 rot="16200000">
            <a:off x="1946520" y="1533240"/>
            <a:ext cx="874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F25 -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ructur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 rot="16200000">
            <a:off x="2396520" y="1387800"/>
            <a:ext cx="1168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F91 - lambdoid J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ructur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 rot="16200000">
            <a:off x="3062880" y="1564200"/>
            <a:ext cx="108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F92 - structur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 rot="16200000">
            <a:off x="4255920" y="1891440"/>
            <a:ext cx="44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F8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 rot="16200000">
            <a:off x="5258880" y="1639080"/>
            <a:ext cx="72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gma fac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1677960" y="2695680"/>
            <a:ext cx="5432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lycin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eava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ste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7" name=""/>
          <p:cNvGrpSpPr/>
          <p:nvPr/>
        </p:nvGrpSpPr>
        <p:grpSpPr>
          <a:xfrm>
            <a:off x="241200" y="3211560"/>
            <a:ext cx="3268800" cy="240840"/>
            <a:chOff x="241200" y="3211560"/>
            <a:chExt cx="3268800" cy="240840"/>
          </a:xfrm>
        </p:grpSpPr>
        <p:sp>
          <p:nvSpPr>
            <p:cNvPr id="578" name=""/>
            <p:cNvSpPr/>
            <p:nvPr/>
          </p:nvSpPr>
          <p:spPr>
            <a:xfrm>
              <a:off x="3075840" y="3211560"/>
              <a:ext cx="4968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 flipV="1">
              <a:off x="241200" y="3329280"/>
              <a:ext cx="3268800" cy="3240"/>
            </a:xfrm>
            <a:prstGeom prst="line">
              <a:avLst/>
            </a:prstGeom>
            <a:ln w="381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2313000" y="3211560"/>
              <a:ext cx="12132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314280" y="3211560"/>
              <a:ext cx="561240" cy="106920"/>
            </a:xfrm>
            <a:prstGeom prst="rect">
              <a:avLst/>
            </a:prstGeom>
            <a:solidFill>
              <a:srgbClr val="fc700b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875520" y="3211560"/>
              <a:ext cx="734400" cy="106920"/>
            </a:xfrm>
            <a:prstGeom prst="rect">
              <a:avLst/>
            </a:prstGeom>
            <a:solidFill>
              <a:srgbClr val="fc700b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3271320" y="3345480"/>
              <a:ext cx="70560" cy="1069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1620000" y="3211560"/>
              <a:ext cx="69264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257760" y="3345480"/>
              <a:ext cx="4068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2855160" y="3211560"/>
              <a:ext cx="4068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2432880" y="3211560"/>
              <a:ext cx="17856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2640960" y="3211560"/>
              <a:ext cx="21420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2899440" y="3211560"/>
              <a:ext cx="16956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3132360" y="3211560"/>
              <a:ext cx="4968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3200760" y="3211560"/>
              <a:ext cx="4968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3362760" y="3345480"/>
              <a:ext cx="19080" cy="106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3400200" y="3211560"/>
              <a:ext cx="70560" cy="106920"/>
            </a:xfrm>
            <a:prstGeom prst="rect">
              <a:avLst/>
            </a:prstGeom>
            <a:solidFill>
              <a:srgbClr val="041ef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4" name=""/>
          <p:cNvSpPr/>
          <p:nvPr/>
        </p:nvSpPr>
        <p:spPr>
          <a:xfrm>
            <a:off x="6315120" y="3186000"/>
            <a:ext cx="100080" cy="1177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 flipV="1">
            <a:off x="3708360" y="3314880"/>
            <a:ext cx="3040200" cy="2880"/>
          </a:xfrm>
          <a:prstGeom prst="line">
            <a:avLst/>
          </a:prstGeom>
          <a:ln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5045040" y="3186000"/>
            <a:ext cx="182520" cy="11772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3776760" y="3186000"/>
            <a:ext cx="129960" cy="117720"/>
          </a:xfrm>
          <a:prstGeom prst="rect">
            <a:avLst/>
          </a:prstGeom>
          <a:solidFill>
            <a:srgbClr val="041ef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>
            <a:off x="6564240" y="3332160"/>
            <a:ext cx="147600" cy="1173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5411880" y="3186000"/>
            <a:ext cx="533160" cy="1177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5227560" y="3186000"/>
            <a:ext cx="95400" cy="117720"/>
          </a:xfrm>
          <a:prstGeom prst="rect">
            <a:avLst/>
          </a:prstGeom>
          <a:solidFill>
            <a:srgbClr val="fc700b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>
            <a:off x="5996160" y="3332160"/>
            <a:ext cx="47520" cy="1173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6051600" y="3186000"/>
            <a:ext cx="210960" cy="117720"/>
          </a:xfrm>
          <a:prstGeom prst="rect">
            <a:avLst/>
          </a:prstGeom>
          <a:solidFill>
            <a:srgbClr val="ffff08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6292800" y="3186000"/>
            <a:ext cx="17640" cy="11772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>
            <a:off x="3921120" y="3186000"/>
            <a:ext cx="128520" cy="1177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4186080" y="3186000"/>
            <a:ext cx="166680" cy="1177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4365720" y="3186000"/>
            <a:ext cx="122040" cy="1177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>
            <a:off x="4513320" y="3186000"/>
            <a:ext cx="96840" cy="1177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4726080" y="3332160"/>
            <a:ext cx="88920" cy="117360"/>
          </a:xfrm>
          <a:prstGeom prst="rect">
            <a:avLst/>
          </a:prstGeom>
          <a:solidFill>
            <a:srgbClr val="041ef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4818240" y="3332160"/>
            <a:ext cx="166680" cy="117360"/>
          </a:xfrm>
          <a:prstGeom prst="rect">
            <a:avLst/>
          </a:prstGeom>
          <a:solidFill>
            <a:srgbClr val="041ef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6427800" y="3332160"/>
            <a:ext cx="120600" cy="1173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 rot="19200000">
            <a:off x="5104080" y="2622240"/>
            <a:ext cx="10065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in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anscrip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gula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 rot="16200000">
            <a:off x="6030720" y="2653200"/>
            <a:ext cx="732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NA-M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py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 rot="16200000">
            <a:off x="5864400" y="2674800"/>
            <a:ext cx="55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gr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 rot="16200000">
            <a:off x="4026600" y="2808720"/>
            <a:ext cx="47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D52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 rot="16200000">
            <a:off x="3078720" y="3303360"/>
            <a:ext cx="102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40bp ga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6" name=""/>
          <p:cNvGrpSpPr/>
          <p:nvPr/>
        </p:nvGrpSpPr>
        <p:grpSpPr>
          <a:xfrm>
            <a:off x="3962520" y="942840"/>
            <a:ext cx="139680" cy="501480"/>
            <a:chOff x="3962520" y="942840"/>
            <a:chExt cx="139680" cy="501480"/>
          </a:xfrm>
        </p:grpSpPr>
        <p:sp>
          <p:nvSpPr>
            <p:cNvPr id="617" name=""/>
            <p:cNvSpPr/>
            <p:nvPr/>
          </p:nvSpPr>
          <p:spPr>
            <a:xfrm>
              <a:off x="3962520" y="942840"/>
              <a:ext cx="139680" cy="132120"/>
            </a:xfrm>
            <a:prstGeom prst="rect">
              <a:avLst/>
            </a:prstGeom>
            <a:solidFill>
              <a:srgbClr val="fc700b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3962520" y="1127160"/>
              <a:ext cx="139680" cy="132480"/>
            </a:xfrm>
            <a:prstGeom prst="rect">
              <a:avLst/>
            </a:prstGeom>
            <a:solidFill>
              <a:srgbClr val="ffff08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"/>
            <p:cNvSpPr/>
            <p:nvPr/>
          </p:nvSpPr>
          <p:spPr>
            <a:xfrm>
              <a:off x="3962520" y="1311840"/>
              <a:ext cx="139680" cy="132480"/>
            </a:xfrm>
            <a:prstGeom prst="rect">
              <a:avLst/>
            </a:prstGeom>
            <a:solidFill>
              <a:srgbClr val="041ef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0" name=""/>
          <p:cNvSpPr/>
          <p:nvPr/>
        </p:nvSpPr>
        <p:spPr>
          <a:xfrm>
            <a:off x="4068720" y="884160"/>
            <a:ext cx="27500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ossible prophage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phage gene similar to P-SS2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posas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511920" y="2514600"/>
            <a:ext cx="8146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thyl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ansfer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type II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>
            <a:off x="70200" y="237168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0,9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 rot="16200000">
            <a:off x="12960" y="1657800"/>
            <a:ext cx="91224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G 02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(RS9917_03943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1800" y="297828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32,82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>
            <a:off x="6363000" y="228600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32,7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6218280" y="3511440"/>
            <a:ext cx="63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65,6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 rot="16200000">
            <a:off x="3615120" y="2685960"/>
            <a:ext cx="61344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_042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 rot="16200000">
            <a:off x="3186360" y="2678760"/>
            <a:ext cx="64548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_04188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 rot="16200000">
            <a:off x="4893120" y="1784880"/>
            <a:ext cx="64548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_0407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 rot="16200000">
            <a:off x="2579040" y="2687760"/>
            <a:ext cx="584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360" rIns="1836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G 412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p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>
            <a:off x="990720" y="3048120"/>
            <a:ext cx="279360" cy="16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 flipH="1">
            <a:off x="601200" y="3048120"/>
            <a:ext cx="23652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5478480" y="2273400"/>
            <a:ext cx="34920" cy="101520"/>
          </a:xfrm>
          <a:prstGeom prst="rect">
            <a:avLst/>
          </a:prstGeom>
          <a:solidFill>
            <a:srgbClr val="041ef6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08T12:52:23Z</dcterms:created>
  <dc:creator>Matthew Sullivan</dc:creator>
  <dc:description/>
  <dc:language>en-US</dc:language>
  <cp:lastModifiedBy>Matthew Sullivan</cp:lastModifiedBy>
  <cp:lastPrinted>2009-04-21T04:35:48Z</cp:lastPrinted>
  <dcterms:modified xsi:type="dcterms:W3CDTF">2009-07-13T07:55:38Z</dcterms:modified>
  <cp:revision>228</cp:revision>
  <dc:subject/>
  <dc:title>x4 members</dc:title>
</cp:coreProperties>
</file>